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108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86E7399-833D-241F-2E8F-03533FDE5A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7AD5D5A-F1E8-E3E9-A114-9022ED0918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5694DFA-E757-5376-80A7-9EA101E8C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490304-835E-D1F7-9074-1621EC99C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22087C7-74E1-59D7-84C5-8B77A29DA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2182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0E39FC-CEB6-B582-586D-7E5ECF4CA5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04B0022-92EB-82F0-EFDF-3B872AF6D9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5DB746-B195-5E57-EAF6-110B60975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F9E2C9-A460-8AA3-B85C-49D2258AA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9E2C54D-4982-6650-80BF-72EBD8097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7607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D86AFC6-AF50-5FD2-2977-5FD56C455B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6AAAF88-28A9-188F-2A3F-24A73AF577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382472B-52EB-34E2-86F8-4B8225596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4DE755-1670-E6C6-2179-F007124241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221B8FF-CF65-FC72-9A05-482273380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739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0DDE90-ED9C-E9F7-E3F4-263FF3481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9A98CA6-4597-EB1D-98F6-2841BE450A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EAC69F6-294A-5C87-1683-0A45CB3C1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0741542-3AE9-C3C2-DB80-9C06553A5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E547FDA-018C-F8AB-F14F-3F1DCFF9B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4340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C770F0-5AB8-F09E-063B-10E807B8E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C33C6F8-3ABA-DB7D-A4DF-61CC8BBBCD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ABB9F92-0C44-C21B-A9C1-A56A17AA8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141BBF2-A8DB-15B6-858E-994B2D03A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47F88FE-5333-7593-66AF-C9E66145F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1025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0E6977-A826-2BD2-2C50-7678A7AD63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A2EB1DB-CC24-8959-DFD6-0FD933CAA7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5EA55BA-2C82-1FA2-F180-9344EA55F0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A5CB0E9-3D60-319E-4F6B-307DD06A6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4E56976-982A-0DBE-3CE1-C789C9308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6030328-AEB5-2BBE-D437-7EE5FD6BC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3589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D8E1C6-8EDD-CC6E-EBF0-CEC2FD31E7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277CCA0-9C2E-5044-5589-2A11DD228B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811B958-A404-BDCB-15BF-E94737C25A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11EE4FA-5863-35E3-455C-95BDE6E6B5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E3FD378-5FE7-96C0-E643-4DA3FBEC5E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3E2A86B-9287-5A74-48B2-8818E69C5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D373770-DCF7-399A-62DC-B1AA12A60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3670FB5-4C82-851F-452A-C0FF858D9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896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BE59FDE-C473-B01F-A0F8-D774968389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99DB36C-4C04-C390-23E3-9E8D87B0E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EC2A756-741E-8442-4547-4A35EC328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5CA746A-5EF4-5A84-B15A-6E634A8BB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8945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E938AEC-7764-728E-4FF6-33866F028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F2092DF9-2EE0-DDB6-31FD-01B738D2A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79D65FE-CA9B-78E5-7B64-13D7484F3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935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BC338A-D9C1-B4BA-39BE-2A59C9FE7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D166ADE-E5B2-B533-793B-5224717253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63120EF-EE1A-239F-D156-76D3D66E39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FD05B0D-4C62-D77F-8782-46CE172B5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65D1058-E604-2B7D-27DF-6C474BE93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98CBDEC-A294-B628-8B51-622BB54F4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4911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950FBB6-B855-863D-ECF4-8EDE63AC5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D15BFAA-EE4E-5E35-B5CE-1C00049571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EBF03ED-0B7B-4E9C-BA26-6A8497FC5B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D4695E0-21FC-1AB4-3C33-0594FA90D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FE254FA-C91F-EB65-66D5-50564F77E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44887CC-6898-1E21-A775-2A5EEACA9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7233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DE8653F-FD4F-9D1B-B129-93231AEBE8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F9ED42B-24EF-6427-C301-F1A86BAA9C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3FAF6EC-BDA2-104A-6361-69009EF480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24ADD-746A-436C-B6D8-9161BACDFC67}" type="datetimeFigureOut">
              <a:rPr lang="ko-KR" altLang="en-US" smtClean="0"/>
              <a:t>2024-0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BF6EADA-7E28-9824-E24F-07F8356BBB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DE239F-CBEF-4396-7715-F275E7C823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ACED4-53EA-412B-B70D-1F383B0CEC3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7245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71081A71-1469-347D-1299-F2E0D3285C49}"/>
              </a:ext>
            </a:extLst>
          </p:cNvPr>
          <p:cNvGrpSpPr/>
          <p:nvPr/>
        </p:nvGrpSpPr>
        <p:grpSpPr>
          <a:xfrm>
            <a:off x="162561" y="1564640"/>
            <a:ext cx="5943600" cy="4216400"/>
            <a:chOff x="1524000" y="0"/>
            <a:chExt cx="9144000" cy="6858000"/>
          </a:xfrm>
        </p:grpSpPr>
        <p:pic>
          <p:nvPicPr>
            <p:cNvPr id="5" name="그래픽 4">
              <a:extLst>
                <a:ext uri="{FF2B5EF4-FFF2-40B4-BE49-F238E27FC236}">
                  <a16:creationId xmlns:a16="http://schemas.microsoft.com/office/drawing/2014/main" id="{BECB9CF6-3F16-0A32-31BC-B5A21B63D4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ED3FB21-34D3-47F6-AFA8-0AB1CAF65D5B}"/>
                </a:ext>
              </a:extLst>
            </p:cNvPr>
            <p:cNvSpPr txBox="1"/>
            <p:nvPr/>
          </p:nvSpPr>
          <p:spPr>
            <a:xfrm>
              <a:off x="5831840" y="1905000"/>
              <a:ext cx="4100314" cy="1201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P = 0.0003</a:t>
              </a:r>
            </a:p>
            <a:p>
              <a:pPr algn="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Low grade = 28.0 (20-33) </a:t>
              </a:r>
              <a:r>
                <a:rPr lang="en-US" altLang="ko-KR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  <a:endParaRPr lang="en-US" altLang="ko-K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High grade = 16.0 (15-18) </a:t>
              </a:r>
              <a:r>
                <a:rPr lang="en-US" altLang="ko-KR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그룹 6">
            <a:extLst>
              <a:ext uri="{FF2B5EF4-FFF2-40B4-BE49-F238E27FC236}">
                <a16:creationId xmlns:a16="http://schemas.microsoft.com/office/drawing/2014/main" id="{5FD43CE6-2996-60B8-2E8B-0AA2FE11D1B4}"/>
              </a:ext>
            </a:extLst>
          </p:cNvPr>
          <p:cNvGrpSpPr/>
          <p:nvPr/>
        </p:nvGrpSpPr>
        <p:grpSpPr>
          <a:xfrm>
            <a:off x="6248400" y="1564640"/>
            <a:ext cx="5943600" cy="4216400"/>
            <a:chOff x="1524000" y="0"/>
            <a:chExt cx="9144000" cy="6858000"/>
          </a:xfrm>
        </p:grpSpPr>
        <p:pic>
          <p:nvPicPr>
            <p:cNvPr id="8" name="그래픽 7">
              <a:extLst>
                <a:ext uri="{FF2B5EF4-FFF2-40B4-BE49-F238E27FC236}">
                  <a16:creationId xmlns:a16="http://schemas.microsoft.com/office/drawing/2014/main" id="{9B01BC46-FD50-80E0-29ED-DF44B71072D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09D80AA-0C57-DB77-83AF-72E53EB3E154}"/>
                </a:ext>
              </a:extLst>
            </p:cNvPr>
            <p:cNvSpPr txBox="1"/>
            <p:nvPr/>
          </p:nvSpPr>
          <p:spPr>
            <a:xfrm>
              <a:off x="5831840" y="1905000"/>
              <a:ext cx="4100314" cy="1201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P = 0.2878</a:t>
              </a:r>
            </a:p>
            <a:p>
              <a:pPr algn="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Low grade = 11.0 (9-15) </a:t>
              </a:r>
              <a:r>
                <a:rPr lang="en-US" altLang="ko-KR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  <a:endParaRPr lang="en-US" altLang="ko-K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High grade = 9.0 (8-10) </a:t>
              </a:r>
              <a:r>
                <a:rPr lang="en-US" altLang="ko-KR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7C07A86A-033C-BA6A-3E5A-08F2DAE3CD0C}"/>
              </a:ext>
            </a:extLst>
          </p:cNvPr>
          <p:cNvSpPr txBox="1"/>
          <p:nvPr/>
        </p:nvSpPr>
        <p:spPr>
          <a:xfrm>
            <a:off x="264160" y="429348"/>
            <a:ext cx="11927840" cy="8695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굴림" panose="020B0600000101010101" pitchFamily="50" charset="-127"/>
                <a:cs typeface="굴림" panose="020B0600000101010101" pitchFamily="50" charset="-127"/>
              </a:rPr>
              <a:t>Supplementary material 2.</a:t>
            </a:r>
            <a:r>
              <a:rPr lang="en-US" altLang="ko-KR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굴림" panose="020B0600000101010101" pitchFamily="50" charset="-127"/>
                <a:cs typeface="굴림" panose="020B0600000101010101" pitchFamily="50" charset="-127"/>
              </a:rPr>
              <a:t>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굴림" panose="020B0600000101010101" pitchFamily="50" charset="-127"/>
                <a:cs typeface="굴림" panose="020B0600000101010101" pitchFamily="50" charset="-127"/>
              </a:rPr>
              <a:t>Overall survival and progression-free survival of metastatic RCC patients by grade except </a:t>
            </a:r>
            <a:r>
              <a:rPr lang="en-US" altLang="ko-KR" sz="18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굴림" panose="020B0600000101010101" pitchFamily="50" charset="-127"/>
                <a:cs typeface="굴림" panose="020B0600000101010101" pitchFamily="50" charset="-127"/>
              </a:rPr>
              <a:t>chromophobe type</a:t>
            </a:r>
            <a:endParaRPr lang="ko-KR" altLang="ko-KR" sz="2000" dirty="0">
              <a:solidFill>
                <a:srgbClr val="000000"/>
              </a:solidFill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402330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6</Words>
  <Application>Microsoft Office PowerPoint</Application>
  <PresentationFormat>와이드스크린</PresentationFormat>
  <Paragraphs>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굴림</vt:lpstr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중원 최</dc:creator>
  <cp:lastModifiedBy>중원 최</cp:lastModifiedBy>
  <cp:revision>3</cp:revision>
  <dcterms:created xsi:type="dcterms:W3CDTF">2024-01-15T14:06:18Z</dcterms:created>
  <dcterms:modified xsi:type="dcterms:W3CDTF">2024-01-15T15:05:26Z</dcterms:modified>
</cp:coreProperties>
</file>